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4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8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FBFB"/>
    <a:srgbClr val="FF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CAF9ED-07DC-4A11-8D7F-57B35C25682E}" styleName="中間スタイル 1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920" autoAdjust="0"/>
    <p:restoredTop sz="96318" autoAdjust="0"/>
  </p:normalViewPr>
  <p:slideViewPr>
    <p:cSldViewPr snapToGrid="0" showGuides="1">
      <p:cViewPr varScale="1">
        <p:scale>
          <a:sx n="65" d="100"/>
          <a:sy n="65" d="100"/>
        </p:scale>
        <p:origin x="2331" y="48"/>
      </p:cViewPr>
      <p:guideLst>
        <p:guide orient="horz" pos="308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3B4F76-D101-4478-A59E-24A65DEE2D74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13F9E7-91F4-41E4-8782-AA54A3F5E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895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6A5B73-E66D-BA58-688B-EEF02092A6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48AAB36-4BA6-1EC8-E30E-41D0D0E8B7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6CC3A3-5D12-314B-0E11-42652A130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CFEC9B-5B43-BB15-E06B-99F9A8F12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9DB512-C055-9B9A-D8A1-DAE92025C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0995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7D5221-C7E3-510B-0D52-92C43C550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343903E-E062-19D7-0486-2BA74BF45D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222409-4106-772F-AB89-9CFC6F26C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4D5A12-02D2-B54A-236C-CD11D2699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7A8B64-4279-579A-32F4-35ABA93C6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941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6252256-827C-74E5-1787-E13C2015BE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6CA120A-DA0E-31ED-8E5B-4BBE39A4F3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548FE9-DFDC-FB71-C7C1-ABC80F2B9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F89AE2-6BF7-4679-78D6-2B917D64C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88E182-FECD-822F-4E13-3B634B2E9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097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0A724C-7024-6859-FA21-BB13E24D9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6A6809-2CAE-15FD-282E-8F518A2AA3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E39DD6-8078-1035-129B-FE5118A8A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FF3530-7B7C-7E27-3F64-CFE574958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A4BAC6-7BD1-95A0-C54F-41E280FD8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9906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F22D45-53B4-E55B-A373-A349CCE82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DEFB30-308D-EB98-32C3-330AFF46E1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89D3AA-BFD2-04FE-341D-B4A7D59EA3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DBE35F-08BB-AF3E-8298-53FBFB853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33C32A-15BE-10D4-5CA0-5AEF79B3B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432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2F956D-C646-BA78-3AAD-AFDAC57AE6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6FB416D-952C-4399-F76C-8B5E2600FB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FEE9141-73EF-209B-25D8-8AD40A183D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945F83-4447-05EE-D44C-0145FE6CF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2BD4F9-2AC5-9778-DB9D-9F91B6B83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85D7CD1-C092-BD2A-43B3-2ACDE21D0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6546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0E46A2-5397-3893-5747-0705E62A98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47A052F-0E8D-29ED-AAA5-A4F0740229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E9B1A22-0E1E-EDB6-6DE7-8490BB1E92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A4C3EE1-0331-0E43-64BC-3DA9893D85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9EDFD60-182C-E5D2-1B75-02F43CE958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3D5D286-35A3-4D22-A09B-7E931E486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ACC7F0D-EF19-F027-EA0D-8C50C0615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CF6F75D-4969-8D3C-10CF-DF4632CDE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78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6B580D-47BD-7A55-2909-65ED8C0E8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2F1C052-F8FB-EC11-8C97-30FD455B9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9DF1FB4-8E73-207D-ED2A-150C2CA3B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331C53D-D051-0879-0A54-770605CA0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438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60D982A-FF5A-0F74-EBBA-F726CC55F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EBC8CF7-8613-F088-AAC1-6015D04F0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202826B-3E32-8063-3476-DD61A3667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605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5D056D-46E7-C3EC-F5D6-A72547DAA6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E9D3A1F-F668-3CD2-B741-7202E9C9F4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E7F3DCC-9EFE-F5E3-4614-9955D0F45F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2E4E076-C948-C0D2-6ED0-D7708510C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2C0AC8-9159-2DF8-EA5B-8423113D2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0F6CBD2-6040-9619-8FEB-50B8B7D99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6556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AFDBE2-974B-EEEB-316C-F467C0E1F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B912812-6927-08E9-88E0-114542BB68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7FBB516-75BB-FAF7-CFD4-6D7706B455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83A911-D8F1-F3F5-C790-D3395C3E7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4D87A3-BB51-F856-6CED-3448CC099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69F362-21AB-E837-07C8-507EB9DE3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168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21175AC-C8B9-7987-179D-9FBD19AC86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85762F9-E0A8-7E75-0058-28229784BE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CA7C3C-207E-03A6-50AA-0CC5149B77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7C58F8-D642-4320-A2F8-10EF1EC83CFB}" type="datetimeFigureOut">
              <a:rPr kumimoji="1" lang="ja-JP" altLang="en-US" smtClean="0"/>
              <a:t>2026/4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EE0C43-5E0F-5817-42E9-C3FFAE917A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D17E5F-406A-B657-D664-F3CD406141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1B38C-0B8E-4DA1-A142-B719652DF0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830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1720BB8-B488-1951-F2AF-D58B13CFB855}"/>
              </a:ext>
            </a:extLst>
          </p:cNvPr>
          <p:cNvSpPr txBox="1"/>
          <p:nvPr/>
        </p:nvSpPr>
        <p:spPr>
          <a:xfrm>
            <a:off x="217539" y="5618498"/>
            <a:ext cx="6422922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Serotonin and noradrenaline levels in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the hypothalamus and striatum after 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Lac-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administration. </a:t>
            </a:r>
          </a:p>
          <a:p>
            <a:pPr algn="just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erotonin levels in the hypothalamus (A) and striatum (B), and noradrenaline levels in the hypothalamus (C) and striatum (D), were measured in tissues collected 30 min, 1 h, and 2 h after intraperitoneal administration of vehicle (saline) or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100 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/mouse). Group sizes were as follows: (A, B) 30 min, vehicle n = 4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4; 1 h, vehicle n = 5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5; 2 h, vehicle n = 5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5. (C) 30 min, vehicle n = 3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3; 1 h, vehicle n = 5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5; 2 h, vehicle n = 5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5. (D) 30 min, vehicle n = 3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4; 1 h, vehicle n = 5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5; 2 h, vehicle n = 5 and Lac-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h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n = 5.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represent the mean ± SEM.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C7AD3245-1E48-98BD-7B9E-6D918680FF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11012"/>
            <a:ext cx="6858000" cy="49591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8711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26</TotalTime>
  <Words>216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乳酸フェニルアラニン(Lac-Phe)と脳機能制御</dc:title>
  <dc:creator>詩萌 鈴木</dc:creator>
  <cp:lastModifiedBy>KENTARO KANEKO</cp:lastModifiedBy>
  <cp:revision>244</cp:revision>
  <dcterms:created xsi:type="dcterms:W3CDTF">2024-07-07T02:36:58Z</dcterms:created>
  <dcterms:modified xsi:type="dcterms:W3CDTF">2026-04-13T02:20:18Z</dcterms:modified>
</cp:coreProperties>
</file>